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2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936ED32-DF7C-4DD5-B529-4C8541CD9C62}" v="3" dt="2022-05-24T14:58:40.69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4" d="100"/>
          <a:sy n="84" d="100"/>
        </p:scale>
        <p:origin x="629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옥성호" userId="a3d85a91-c244-472f-b6d7-e57be5a1eb88" providerId="ADAL" clId="{97569310-0CA6-46DE-BB99-D569AC2439CE}"/>
    <pc:docChg chg="undo custSel addSld modSld">
      <pc:chgData name="옥성호" userId="a3d85a91-c244-472f-b6d7-e57be5a1eb88" providerId="ADAL" clId="{97569310-0CA6-46DE-BB99-D569AC2439CE}" dt="2022-05-25T12:42:44.733" v="14" actId="20577"/>
      <pc:docMkLst>
        <pc:docMk/>
      </pc:docMkLst>
      <pc:sldChg chg="addSp delSp modSp new mod">
        <pc:chgData name="옥성호" userId="a3d85a91-c244-472f-b6d7-e57be5a1eb88" providerId="ADAL" clId="{97569310-0CA6-46DE-BB99-D569AC2439CE}" dt="2022-05-25T12:42:44.733" v="14" actId="20577"/>
        <pc:sldMkLst>
          <pc:docMk/>
          <pc:sldMk cId="3823543281" sldId="257"/>
        </pc:sldMkLst>
        <pc:spChg chg="del">
          <ac:chgData name="옥성호" userId="a3d85a91-c244-472f-b6d7-e57be5a1eb88" providerId="ADAL" clId="{97569310-0CA6-46DE-BB99-D569AC2439CE}" dt="2022-05-25T12:42:11.691" v="2" actId="478"/>
          <ac:spMkLst>
            <pc:docMk/>
            <pc:sldMk cId="3823543281" sldId="257"/>
            <ac:spMk id="2" creationId="{C3BD0A79-6CA3-36C6-2E01-9F33F259B09A}"/>
          </ac:spMkLst>
        </pc:spChg>
        <pc:spChg chg="del">
          <ac:chgData name="옥성호" userId="a3d85a91-c244-472f-b6d7-e57be5a1eb88" providerId="ADAL" clId="{97569310-0CA6-46DE-BB99-D569AC2439CE}" dt="2022-05-25T12:42:10.618" v="1" actId="478"/>
          <ac:spMkLst>
            <pc:docMk/>
            <pc:sldMk cId="3823543281" sldId="257"/>
            <ac:spMk id="3" creationId="{E3CD5C7B-6F4F-50CE-D474-9BF22ED6A244}"/>
          </ac:spMkLst>
        </pc:spChg>
        <pc:spChg chg="add del">
          <ac:chgData name="옥성호" userId="a3d85a91-c244-472f-b6d7-e57be5a1eb88" providerId="ADAL" clId="{97569310-0CA6-46DE-BB99-D569AC2439CE}" dt="2022-05-25T12:42:15.637" v="4" actId="22"/>
          <ac:spMkLst>
            <pc:docMk/>
            <pc:sldMk cId="3823543281" sldId="257"/>
            <ac:spMk id="5" creationId="{EB18CF26-45BC-B6A3-35C8-D9EA8D33573A}"/>
          </ac:spMkLst>
        </pc:spChg>
        <pc:spChg chg="add mod">
          <ac:chgData name="옥성호" userId="a3d85a91-c244-472f-b6d7-e57be5a1eb88" providerId="ADAL" clId="{97569310-0CA6-46DE-BB99-D569AC2439CE}" dt="2022-05-25T12:42:44.733" v="14" actId="20577"/>
          <ac:spMkLst>
            <pc:docMk/>
            <pc:sldMk cId="3823543281" sldId="257"/>
            <ac:spMk id="7" creationId="{F2DB3908-99EF-E49C-5D37-07C9DBBA0385}"/>
          </ac:spMkLst>
        </pc:spChg>
      </pc:sldChg>
    </pc:docChg>
  </pc:docChgLst>
  <pc:docChgLst>
    <pc:chgData name="옥성호" userId="a3d85a91-c244-472f-b6d7-e57be5a1eb88" providerId="ADAL" clId="{D7B494FC-A94D-4696-A68C-2C774F0D280F}"/>
    <pc:docChg chg="undo custSel addSld modSld">
      <pc:chgData name="옥성호" userId="a3d85a91-c244-472f-b6d7-e57be5a1eb88" providerId="ADAL" clId="{D7B494FC-A94D-4696-A68C-2C774F0D280F}" dt="2022-05-22T03:07:32.644" v="190" actId="1076"/>
      <pc:docMkLst>
        <pc:docMk/>
      </pc:docMkLst>
      <pc:sldChg chg="addSp delSp modSp new mod setBg">
        <pc:chgData name="옥성호" userId="a3d85a91-c244-472f-b6d7-e57be5a1eb88" providerId="ADAL" clId="{D7B494FC-A94D-4696-A68C-2C774F0D280F}" dt="2022-05-22T03:07:32.644" v="190" actId="1076"/>
        <pc:sldMkLst>
          <pc:docMk/>
          <pc:sldMk cId="3889853936" sldId="256"/>
        </pc:sldMkLst>
        <pc:spChg chg="del">
          <ac:chgData name="옥성호" userId="a3d85a91-c244-472f-b6d7-e57be5a1eb88" providerId="ADAL" clId="{D7B494FC-A94D-4696-A68C-2C774F0D280F}" dt="2022-05-22T02:57:47.296" v="1" actId="478"/>
          <ac:spMkLst>
            <pc:docMk/>
            <pc:sldMk cId="3889853936" sldId="256"/>
            <ac:spMk id="2" creationId="{42EB8E77-B21A-FA9F-6102-F4A6EFDB9CF8}"/>
          </ac:spMkLst>
        </pc:spChg>
        <pc:spChg chg="del">
          <ac:chgData name="옥성호" userId="a3d85a91-c244-472f-b6d7-e57be5a1eb88" providerId="ADAL" clId="{D7B494FC-A94D-4696-A68C-2C774F0D280F}" dt="2022-05-22T02:57:48.549" v="2" actId="478"/>
          <ac:spMkLst>
            <pc:docMk/>
            <pc:sldMk cId="3889853936" sldId="256"/>
            <ac:spMk id="3" creationId="{780E7014-B822-473E-88DD-80E653B33B42}"/>
          </ac:spMkLst>
        </pc:spChg>
        <pc:spChg chg="add mod">
          <ac:chgData name="옥성호" userId="a3d85a91-c244-472f-b6d7-e57be5a1eb88" providerId="ADAL" clId="{D7B494FC-A94D-4696-A68C-2C774F0D280F}" dt="2022-05-22T03:00:39.714" v="161" actId="14100"/>
          <ac:spMkLst>
            <pc:docMk/>
            <pc:sldMk cId="3889853936" sldId="256"/>
            <ac:spMk id="10" creationId="{264ADF14-D4D9-ABD1-0B84-C5B4A480BCC7}"/>
          </ac:spMkLst>
        </pc:spChg>
        <pc:spChg chg="add del mod">
          <ac:chgData name="옥성호" userId="a3d85a91-c244-472f-b6d7-e57be5a1eb88" providerId="ADAL" clId="{D7B494FC-A94D-4696-A68C-2C774F0D280F}" dt="2022-05-22T03:06:45.714" v="175" actId="767"/>
          <ac:spMkLst>
            <pc:docMk/>
            <pc:sldMk cId="3889853936" sldId="256"/>
            <ac:spMk id="11" creationId="{3DA118CA-A528-295B-6CE8-9407989B0370}"/>
          </ac:spMkLst>
        </pc:spChg>
        <pc:spChg chg="add mod">
          <ac:chgData name="옥성호" userId="a3d85a91-c244-472f-b6d7-e57be5a1eb88" providerId="ADAL" clId="{D7B494FC-A94D-4696-A68C-2C774F0D280F}" dt="2022-05-22T03:07:10.236" v="183" actId="1076"/>
          <ac:spMkLst>
            <pc:docMk/>
            <pc:sldMk cId="3889853936" sldId="256"/>
            <ac:spMk id="12" creationId="{8CF37D86-E855-BA2D-D7FB-4AD667DC2DBC}"/>
          </ac:spMkLst>
        </pc:spChg>
        <pc:spChg chg="add mod">
          <ac:chgData name="옥성호" userId="a3d85a91-c244-472f-b6d7-e57be5a1eb88" providerId="ADAL" clId="{D7B494FC-A94D-4696-A68C-2C774F0D280F}" dt="2022-05-22T03:01:16.851" v="173" actId="20577"/>
          <ac:spMkLst>
            <pc:docMk/>
            <pc:sldMk cId="3889853936" sldId="256"/>
            <ac:spMk id="13" creationId="{60CE2CB5-5639-8193-A796-327663A27A04}"/>
          </ac:spMkLst>
        </pc:spChg>
        <pc:spChg chg="add mod">
          <ac:chgData name="옥성호" userId="a3d85a91-c244-472f-b6d7-e57be5a1eb88" providerId="ADAL" clId="{D7B494FC-A94D-4696-A68C-2C774F0D280F}" dt="2022-05-22T03:01:13.563" v="172" actId="20577"/>
          <ac:spMkLst>
            <pc:docMk/>
            <pc:sldMk cId="3889853936" sldId="256"/>
            <ac:spMk id="15" creationId="{A9A5CD08-2547-51F6-D4C2-3BBD08F66F4C}"/>
          </ac:spMkLst>
        </pc:spChg>
        <pc:spChg chg="add mod">
          <ac:chgData name="옥성호" userId="a3d85a91-c244-472f-b6d7-e57be5a1eb88" providerId="ADAL" clId="{D7B494FC-A94D-4696-A68C-2C774F0D280F}" dt="2022-05-22T03:07:32.644" v="190" actId="1076"/>
          <ac:spMkLst>
            <pc:docMk/>
            <pc:sldMk cId="3889853936" sldId="256"/>
            <ac:spMk id="17" creationId="{424F3D5E-24A4-39F9-F764-2D12B599F47A}"/>
          </ac:spMkLst>
        </pc:spChg>
        <pc:picChg chg="add mod">
          <ac:chgData name="옥성호" userId="a3d85a91-c244-472f-b6d7-e57be5a1eb88" providerId="ADAL" clId="{D7B494FC-A94D-4696-A68C-2C774F0D280F}" dt="2022-05-22T02:59:25.145" v="33" actId="26606"/>
          <ac:picMkLst>
            <pc:docMk/>
            <pc:sldMk cId="3889853936" sldId="256"/>
            <ac:picMk id="5" creationId="{47D5D9ED-F30B-A7E9-DD15-BD7833DF4DB2}"/>
          </ac:picMkLst>
        </pc:picChg>
        <pc:picChg chg="add mod ord">
          <ac:chgData name="옥성호" userId="a3d85a91-c244-472f-b6d7-e57be5a1eb88" providerId="ADAL" clId="{D7B494FC-A94D-4696-A68C-2C774F0D280F}" dt="2022-05-22T02:59:53.339" v="145" actId="1038"/>
          <ac:picMkLst>
            <pc:docMk/>
            <pc:sldMk cId="3889853936" sldId="256"/>
            <ac:picMk id="7" creationId="{01CD2F61-D40D-74F4-A909-CF8F6F3E8913}"/>
          </ac:picMkLst>
        </pc:picChg>
        <pc:picChg chg="add mod">
          <ac:chgData name="옥성호" userId="a3d85a91-c244-472f-b6d7-e57be5a1eb88" providerId="ADAL" clId="{D7B494FC-A94D-4696-A68C-2C774F0D280F}" dt="2022-05-22T03:00:06.490" v="150" actId="1035"/>
          <ac:picMkLst>
            <pc:docMk/>
            <pc:sldMk cId="3889853936" sldId="256"/>
            <ac:picMk id="9" creationId="{B61F19C8-B04E-2567-C2CC-D04F6403EE30}"/>
          </ac:picMkLst>
        </pc:picChg>
        <pc:cxnChg chg="add">
          <ac:chgData name="옥성호" userId="a3d85a91-c244-472f-b6d7-e57be5a1eb88" providerId="ADAL" clId="{D7B494FC-A94D-4696-A68C-2C774F0D280F}" dt="2022-05-22T02:59:25.145" v="33" actId="26606"/>
          <ac:cxnSpMkLst>
            <pc:docMk/>
            <pc:sldMk cId="3889853936" sldId="256"/>
            <ac:cxnSpMk id="14" creationId="{DCD67800-37AC-4E14-89B0-F79DCB3FB86D}"/>
          </ac:cxnSpMkLst>
        </pc:cxnChg>
        <pc:cxnChg chg="add">
          <ac:chgData name="옥성호" userId="a3d85a91-c244-472f-b6d7-e57be5a1eb88" providerId="ADAL" clId="{D7B494FC-A94D-4696-A68C-2C774F0D280F}" dt="2022-05-22T02:59:25.145" v="33" actId="26606"/>
          <ac:cxnSpMkLst>
            <pc:docMk/>
            <pc:sldMk cId="3889853936" sldId="256"/>
            <ac:cxnSpMk id="16" creationId="{20F1788F-A5AE-4188-8274-F7F2E3833ECD}"/>
          </ac:cxnSpMkLst>
        </pc:cxnChg>
      </pc:sldChg>
    </pc:docChg>
  </pc:docChgLst>
  <pc:docChgLst>
    <pc:chgData name="옥성호" userId="a3d85a91-c244-472f-b6d7-e57be5a1eb88" providerId="ADAL" clId="{4936ED32-DF7C-4DD5-B529-4C8541CD9C62}"/>
    <pc:docChg chg="custSel modSld">
      <pc:chgData name="옥성호" userId="a3d85a91-c244-472f-b6d7-e57be5a1eb88" providerId="ADAL" clId="{4936ED32-DF7C-4DD5-B529-4C8541CD9C62}" dt="2022-05-24T14:58:44.334" v="14" actId="1076"/>
      <pc:docMkLst>
        <pc:docMk/>
      </pc:docMkLst>
      <pc:sldChg chg="addSp delSp modSp mod">
        <pc:chgData name="옥성호" userId="a3d85a91-c244-472f-b6d7-e57be5a1eb88" providerId="ADAL" clId="{4936ED32-DF7C-4DD5-B529-4C8541CD9C62}" dt="2022-05-24T14:58:44.334" v="14" actId="1076"/>
        <pc:sldMkLst>
          <pc:docMk/>
          <pc:sldMk cId="3889853936" sldId="256"/>
        </pc:sldMkLst>
        <pc:spChg chg="add mod">
          <ac:chgData name="옥성호" userId="a3d85a91-c244-472f-b6d7-e57be5a1eb88" providerId="ADAL" clId="{4936ED32-DF7C-4DD5-B529-4C8541CD9C62}" dt="2022-05-24T14:58:30.749" v="10" actId="20577"/>
          <ac:spMkLst>
            <pc:docMk/>
            <pc:sldMk cId="3889853936" sldId="256"/>
            <ac:spMk id="18" creationId="{02E839D2-B2FB-1099-40E6-F908C3383A05}"/>
          </ac:spMkLst>
        </pc:spChg>
        <pc:spChg chg="add del mod">
          <ac:chgData name="옥성호" userId="a3d85a91-c244-472f-b6d7-e57be5a1eb88" providerId="ADAL" clId="{4936ED32-DF7C-4DD5-B529-4C8541CD9C62}" dt="2022-05-24T14:58:37.527" v="12" actId="478"/>
          <ac:spMkLst>
            <pc:docMk/>
            <pc:sldMk cId="3889853936" sldId="256"/>
            <ac:spMk id="19" creationId="{F192A5AE-EAE1-CAE1-3125-F9503586F6DB}"/>
          </ac:spMkLst>
        </pc:spChg>
        <pc:spChg chg="add mod">
          <ac:chgData name="옥성호" userId="a3d85a91-c244-472f-b6d7-e57be5a1eb88" providerId="ADAL" clId="{4936ED32-DF7C-4DD5-B529-4C8541CD9C62}" dt="2022-05-24T14:58:44.334" v="14" actId="1076"/>
          <ac:spMkLst>
            <pc:docMk/>
            <pc:sldMk cId="3889853936" sldId="256"/>
            <ac:spMk id="20" creationId="{89594CB6-7BA4-8CDA-1DDB-35ABACE246B0}"/>
          </ac:spMkLst>
        </pc:spChg>
      </pc:sldChg>
    </pc:docChg>
  </pc:docChgLst>
</pc:chgInfo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2-05-22T23:25:06.041" idx="1">
    <p:pos x="2521" y="1048"/>
    <p:text>Please include the labels for the arteries in panels a and c as you have included in panel b.</p:text>
    <p:extLst>
      <p:ext uri="{C676402C-5697-4E1C-873F-D02D1690AC5C}">
        <p15:threadingInfo xmlns:p15="http://schemas.microsoft.com/office/powerpoint/2012/main" timeZoneBias="-330"/>
      </p:ext>
    </p:extLst>
  </p:cm>
  <p:cm authorId="1" dt="2022-05-22T23:27:49.176" idx="2">
    <p:pos x="2521" y="1184"/>
    <p:text>I would also suggest that you submit this figure as a PDF, .JPEG, or .TIFF file</p:text>
    <p:extLst>
      <p:ext uri="{C676402C-5697-4E1C-873F-D02D1690AC5C}">
        <p15:threadingInfo xmlns:p15="http://schemas.microsoft.com/office/powerpoint/2012/main" timeZoneBias="-330">
          <p15:parentCm authorId="1" idx="1"/>
        </p15:threadingInfo>
      </p:ext>
    </p:extLs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4FD2BD46-49E2-6E86-5F73-74531C8613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xmlns="" id="{FF05030F-A216-BDF6-17AB-36B3E38F48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4D04E998-C470-D173-D623-9F6488955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634E-7C51-4FEC-BF60-6F21DD134886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92175953-BB37-B322-0E2D-3EFA7FF556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1C56E95D-4C89-138A-DED9-4F11F22371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CE926-618D-4937-83D7-1283DBE478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48849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15B775AD-8AAC-3E37-B91A-EFCC1A2F1F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xmlns="" id="{3061F3CD-3198-40BC-CE90-59956372E2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FA110C32-457B-5814-46AA-F27A8908A7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634E-7C51-4FEC-BF60-6F21DD134886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0D0EB559-1F73-BB87-83E8-CF426DB71E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9F746263-B1DC-78DC-4755-9CB62BD065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CE926-618D-4937-83D7-1283DBE478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1282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xmlns="" id="{D05CCA3A-7BE7-8918-45D2-F2BACC647F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xmlns="" id="{3F2BF8CD-70FD-653A-35F1-DFBE6323DC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D0FCD5E9-A8D5-C10F-635A-79036FCECF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634E-7C51-4FEC-BF60-6F21DD134886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B1500082-A7A8-7263-A412-89A657586A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81AE224F-29B9-4BB8-5D92-2CF8BAFFA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CE926-618D-4937-83D7-1283DBE478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3128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EC4B2FAB-FF24-7370-2469-0D2B3EEBD1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51FE2810-6170-EF9C-FA89-76C65E842F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C55D93A6-2004-973D-2E71-744D2F54DE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634E-7C51-4FEC-BF60-6F21DD134886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6941670F-3E41-F775-62E6-031128BBA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010A13C3-9429-0F91-E34C-A6BF1B2C7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CE926-618D-4937-83D7-1283DBE478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78099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8BAF5D3E-2FF3-63A5-C4B0-CCEB236541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FCEB51DA-D0D9-8EBA-612C-8DF0F657FE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08F20880-FE84-7722-AA55-CE949E787B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634E-7C51-4FEC-BF60-6F21DD134886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6E8B5899-EDCC-0F0C-A928-39C0ADBCB2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71CF86DD-B158-CFDF-53A8-27AE73359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CE926-618D-4937-83D7-1283DBE478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108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7AED893B-1827-496C-FF38-DFC489EC10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D63A3743-857A-AD69-497C-7261893D1A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xmlns="" id="{8C4C5F57-6527-AB9A-93B1-9E1141580F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7E935659-31A9-2925-7E99-0474CF5CC2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634E-7C51-4FEC-BF60-6F21DD134886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173E1E73-1CAA-1D96-16F7-37957AED04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01DC31FB-1EBA-1EE5-4C01-CCB24CE1B6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CE926-618D-4937-83D7-1283DBE478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2937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13BF367D-785A-FCB9-4518-9CF14729FD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A80566BC-BF79-13F6-C68A-9163A81531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xmlns="" id="{9E6086A0-22DB-C2D5-CAC1-AECA66148F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xmlns="" id="{0DD1F7DE-D0D8-6944-319D-13F628AD75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xmlns="" id="{18B2C6E9-8D5B-42D2-761D-CECCE7FF049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xmlns="" id="{8F852CE9-AC5F-D9F5-8C5D-9289AF0612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634E-7C51-4FEC-BF60-6F21DD134886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xmlns="" id="{C5B634CB-032D-07E0-57F6-72C5DA3C2E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xmlns="" id="{C9359912-1365-4F7B-042E-747F695903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CE926-618D-4937-83D7-1283DBE478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2207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AD536EE0-FAFF-4DD5-DBFB-0C1AAE1600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xmlns="" id="{7E66A57D-A01B-AADB-ABDB-3FC8AD5E88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634E-7C51-4FEC-BF60-6F21DD134886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xmlns="" id="{0D167BFA-7BB3-BEDD-523B-A0EC4734EA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xmlns="" id="{FA4CC4D9-7EEA-1D9A-DCD3-C49E635BC5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CE926-618D-4937-83D7-1283DBE478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07962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xmlns="" id="{963FE38B-9D94-0E76-1B0F-E84E46DAC0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634E-7C51-4FEC-BF60-6F21DD134886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xmlns="" id="{F33A4034-6E30-8F97-63B8-53B20CD25E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xmlns="" id="{BA006344-B791-40BF-F746-FA1E1359A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CE926-618D-4937-83D7-1283DBE478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57568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98C0AEE4-14E4-9BC8-A6B0-24755CC1CB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A446E5C3-3B99-5BA2-6D58-6BF4E6F1C0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xmlns="" id="{5288A609-363F-E66C-28CC-2FB409A576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432DA08E-5E63-EA44-06A7-47F527C77F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634E-7C51-4FEC-BF60-6F21DD134886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5A2BE513-E6DD-3EE3-A81A-530730C7DE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334500E8-5988-DB17-B444-4417474A2A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CE926-618D-4937-83D7-1283DBE478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52288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83193379-42E2-1C4F-174F-5147A724AD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xmlns="" id="{FD7B1589-7726-53FC-CFE3-0AF478E9C7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xmlns="" id="{D6BF8E2B-1357-8AF3-AD67-42019CBD8D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E3204BA8-9770-E4DF-3FFA-02A16E2F8C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F634E-7C51-4FEC-BF60-6F21DD134886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6ADD319E-51D8-39AA-B871-9850B57B95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030860D2-4720-4DCD-5773-88CFCAE4D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ECE926-618D-4937-83D7-1283DBE478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72688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xmlns="" id="{8924D6F8-2717-09A6-7258-F0B39AAD39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0A0CD520-1974-795E-2E2C-5492494873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17810331-224B-CE61-63D9-3EB449297A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3F634E-7C51-4FEC-BF60-6F21DD134886}" type="datetimeFigureOut">
              <a:rPr lang="ko-KR" altLang="en-US" smtClean="0"/>
              <a:t>2022-06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2E86455C-D210-8601-4B95-5A2D156AF5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E20809D1-BA09-37A2-493F-EEE37A40D9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ECE926-618D-4937-83D7-1283DBE478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71351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comments" Target="../comments/comment1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xmlns="" id="{47D5D9ED-F30B-A7E9-DD15-BD7833DF4DB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632" y="1662960"/>
            <a:ext cx="3517119" cy="3525933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xmlns="" id="{DCD67800-37AC-4E14-89B0-F79DCB3FB86D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xmlns="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그림 8" descr="모기장, 선화이(가) 표시된 사진&#10;&#10;자동 생성된 설명">
            <a:extLst>
              <a:ext uri="{FF2B5EF4-FFF2-40B4-BE49-F238E27FC236}">
                <a16:creationId xmlns:a16="http://schemas.microsoft.com/office/drawing/2014/main" xmlns="" id="{B61F19C8-B04E-2567-C2CC-D04F6403EE3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9444" y="1666335"/>
            <a:ext cx="3537345" cy="3501971"/>
          </a:xfrm>
          <a:prstGeom prst="rect">
            <a:avLst/>
          </a:prstGeom>
        </p:spPr>
      </p:pic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xmlns="" id="{20F1788F-A5AE-4188-8274-F7F2E3833ECD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xmlns="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그림 6" descr="실내이(가) 표시된 사진&#10;&#10;자동 생성된 설명">
            <a:extLst>
              <a:ext uri="{FF2B5EF4-FFF2-40B4-BE49-F238E27FC236}">
                <a16:creationId xmlns:a16="http://schemas.microsoft.com/office/drawing/2014/main" xmlns="" id="{01CD2F61-D40D-74F4-A909-CF8F6F3E891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0144" y="1671764"/>
            <a:ext cx="3517120" cy="3508327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264ADF14-D4D9-ABD1-0B84-C5B4A480BCC7}"/>
              </a:ext>
            </a:extLst>
          </p:cNvPr>
          <p:cNvSpPr txBox="1"/>
          <p:nvPr/>
        </p:nvSpPr>
        <p:spPr>
          <a:xfrm>
            <a:off x="484632" y="779929"/>
            <a:ext cx="6185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800" b="1" dirty="0"/>
              <a:t>A</a:t>
            </a:r>
            <a:endParaRPr lang="ko-KR" altLang="en-US" sz="28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60CE2CB5-5639-8193-A796-327663A27A04}"/>
              </a:ext>
            </a:extLst>
          </p:cNvPr>
          <p:cNvSpPr txBox="1"/>
          <p:nvPr/>
        </p:nvSpPr>
        <p:spPr>
          <a:xfrm>
            <a:off x="4340144" y="779929"/>
            <a:ext cx="6185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800" b="1" dirty="0"/>
              <a:t>B</a:t>
            </a:r>
            <a:endParaRPr lang="ko-KR" altLang="en-US" sz="2800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A9A5CD08-2547-51F6-D4C2-3BBD08F66F4C}"/>
              </a:ext>
            </a:extLst>
          </p:cNvPr>
          <p:cNvSpPr txBox="1"/>
          <p:nvPr/>
        </p:nvSpPr>
        <p:spPr>
          <a:xfrm>
            <a:off x="8169444" y="779929"/>
            <a:ext cx="6185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800" b="1" dirty="0"/>
              <a:t>C</a:t>
            </a:r>
            <a:endParaRPr lang="ko-KR" altLang="en-US" sz="28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8CF37D86-E855-BA2D-D7FB-4AD667DC2DBC}"/>
              </a:ext>
            </a:extLst>
          </p:cNvPr>
          <p:cNvSpPr txBox="1"/>
          <p:nvPr/>
        </p:nvSpPr>
        <p:spPr>
          <a:xfrm>
            <a:off x="6286500" y="2124635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LAD</a:t>
            </a:r>
            <a:endParaRPr lang="ko-KR" altLang="en-US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424F3D5E-24A4-39F9-F764-2D12B599F47A}"/>
              </a:ext>
            </a:extLst>
          </p:cNvPr>
          <p:cNvSpPr txBox="1"/>
          <p:nvPr/>
        </p:nvSpPr>
        <p:spPr>
          <a:xfrm>
            <a:off x="5829300" y="3817321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err="1"/>
              <a:t>LCx</a:t>
            </a:r>
            <a:endParaRPr lang="ko-KR" altLang="en-US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02E839D2-B2FB-1099-40E6-F908C3383A05}"/>
              </a:ext>
            </a:extLst>
          </p:cNvPr>
          <p:cNvSpPr txBox="1"/>
          <p:nvPr/>
        </p:nvSpPr>
        <p:spPr>
          <a:xfrm>
            <a:off x="9346420" y="3915335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RCA</a:t>
            </a:r>
            <a:endParaRPr lang="ko-KR" altLang="en-US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89594CB6-7BA4-8CDA-1DDB-35ABACE246B0}"/>
              </a:ext>
            </a:extLst>
          </p:cNvPr>
          <p:cNvSpPr txBox="1"/>
          <p:nvPr/>
        </p:nvSpPr>
        <p:spPr>
          <a:xfrm>
            <a:off x="2769380" y="2124635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LAD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38898539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F2DB3908-99EF-E49C-5D37-07C9DBBA0385}"/>
              </a:ext>
            </a:extLst>
          </p:cNvPr>
          <p:cNvSpPr txBox="1"/>
          <p:nvPr/>
        </p:nvSpPr>
        <p:spPr>
          <a:xfrm>
            <a:off x="1399922" y="1072854"/>
            <a:ext cx="9394852" cy="31207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1">
              <a:lnSpc>
                <a:spcPct val="115000"/>
              </a:lnSpc>
              <a:spcAft>
                <a:spcPts val="800"/>
              </a:spcAft>
            </a:pPr>
            <a:r>
              <a:rPr lang="en-US" altLang="ko-KR" sz="2400" b="1" kern="100" dirty="0">
                <a:effectLst/>
                <a:latin typeface="맑은 고딕" panose="020B0503020000020004" pitchFamily="50" charset="-127"/>
                <a:ea typeface="맑은 고딕" panose="020B0503020000020004" pitchFamily="50" charset="-127"/>
                <a:cs typeface="Arial" panose="020B0604020202020204" pitchFamily="34" charset="0"/>
              </a:rPr>
              <a:t>Figure Legend</a:t>
            </a:r>
          </a:p>
          <a:p>
            <a:pPr algn="just" latinLnBrk="1">
              <a:lnSpc>
                <a:spcPct val="115000"/>
              </a:lnSpc>
              <a:spcAft>
                <a:spcPts val="800"/>
              </a:spcAft>
            </a:pPr>
            <a:r>
              <a:rPr lang="en-US" altLang="ko-KR" sz="2400" b="1" kern="100" dirty="0">
                <a:effectLst/>
                <a:latin typeface="맑은 고딕" panose="020B0503020000020004" pitchFamily="50" charset="-127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endParaRPr lang="ko-KR" altLang="ko-KR" sz="16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pPr algn="just" latinLnBrk="1">
              <a:lnSpc>
                <a:spcPct val="115000"/>
              </a:lnSpc>
              <a:spcAft>
                <a:spcPts val="800"/>
              </a:spcAft>
            </a:pPr>
            <a:r>
              <a:rPr lang="en-US" altLang="ko-KR" sz="1800" b="1" kern="100">
                <a:effectLst/>
                <a:latin typeface="맑은 고딕" panose="020B0503020000020004" pitchFamily="50" charset="-127"/>
                <a:ea typeface="맑은 고딕" panose="020B0503020000020004" pitchFamily="50" charset="-127"/>
                <a:cs typeface="Arial" panose="020B0604020202020204" pitchFamily="34" charset="0"/>
              </a:rPr>
              <a:t>Supplemental </a:t>
            </a:r>
            <a:r>
              <a:rPr lang="en-US" altLang="ko-KR" sz="1800" b="1" kern="100" smtClean="0">
                <a:effectLst/>
                <a:latin typeface="맑은 고딕" panose="020B0503020000020004" pitchFamily="50" charset="-127"/>
                <a:ea typeface="맑은 고딕" panose="020B0503020000020004" pitchFamily="50" charset="-127"/>
                <a:cs typeface="Arial" panose="020B0604020202020204" pitchFamily="34" charset="0"/>
              </a:rPr>
              <a:t>Figure S1</a:t>
            </a:r>
            <a:endParaRPr lang="ko-KR" altLang="ko-KR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pPr algn="just" latinLnBrk="1">
              <a:lnSpc>
                <a:spcPct val="115000"/>
              </a:lnSpc>
              <a:spcAft>
                <a:spcPts val="800"/>
              </a:spcAft>
            </a:pPr>
            <a:r>
              <a:rPr lang="en-US" altLang="ko-KR" sz="1800" kern="100" dirty="0">
                <a:effectLst/>
                <a:latin typeface="맑은 고딕" panose="020B0503020000020004" pitchFamily="50" charset="-127"/>
                <a:ea typeface="맑은 고딕" panose="020B0503020000020004" pitchFamily="50" charset="-127"/>
                <a:cs typeface="Arial" panose="020B0604020202020204" pitchFamily="34" charset="0"/>
              </a:rPr>
              <a:t>Coronary angiography scan performed after admission to intensive care unit</a:t>
            </a:r>
            <a:endParaRPr lang="ko-KR" altLang="ko-KR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pPr algn="just" latinLnBrk="1">
              <a:lnSpc>
                <a:spcPct val="115000"/>
              </a:lnSpc>
              <a:spcAft>
                <a:spcPts val="800"/>
              </a:spcAft>
            </a:pPr>
            <a:r>
              <a:rPr lang="en-US" altLang="ko-KR" sz="1800" b="1" kern="100" dirty="0">
                <a:effectLst/>
                <a:latin typeface="맑은 고딕" panose="020B0503020000020004" pitchFamily="50" charset="-127"/>
                <a:ea typeface="맑은 고딕" panose="020B0503020000020004" pitchFamily="50" charset="-127"/>
                <a:cs typeface="Arial" panose="020B0604020202020204" pitchFamily="34" charset="0"/>
              </a:rPr>
              <a:t>A.</a:t>
            </a:r>
            <a:r>
              <a:rPr lang="en-US" altLang="ko-KR" sz="1800" kern="100" dirty="0">
                <a:effectLst/>
                <a:latin typeface="맑은 고딕" panose="020B0503020000020004" pitchFamily="50" charset="-127"/>
                <a:ea typeface="맑은 고딕" panose="020B0503020000020004" pitchFamily="50" charset="-127"/>
                <a:cs typeface="Arial" panose="020B0604020202020204" pitchFamily="34" charset="0"/>
              </a:rPr>
              <a:t> Left anterior descending artery (LAD) without significant stenosis and occlusion</a:t>
            </a:r>
            <a:endParaRPr lang="ko-KR" altLang="ko-KR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pPr algn="just" latinLnBrk="1">
              <a:lnSpc>
                <a:spcPct val="115000"/>
              </a:lnSpc>
              <a:spcAft>
                <a:spcPts val="800"/>
              </a:spcAft>
            </a:pPr>
            <a:r>
              <a:rPr lang="en-US" altLang="ko-KR" sz="1800" b="1" kern="100" dirty="0">
                <a:effectLst/>
                <a:latin typeface="맑은 고딕" panose="020B0503020000020004" pitchFamily="50" charset="-127"/>
                <a:ea typeface="맑은 고딕" panose="020B0503020000020004" pitchFamily="50" charset="-127"/>
                <a:cs typeface="Arial" panose="020B0604020202020204" pitchFamily="34" charset="0"/>
              </a:rPr>
              <a:t>B.</a:t>
            </a:r>
            <a:r>
              <a:rPr lang="en-US" altLang="ko-KR" sz="1800" kern="100" dirty="0">
                <a:effectLst/>
                <a:latin typeface="맑은 고딕" panose="020B0503020000020004" pitchFamily="50" charset="-127"/>
                <a:ea typeface="맑은 고딕" panose="020B0503020000020004" pitchFamily="50" charset="-127"/>
                <a:cs typeface="Arial" panose="020B0604020202020204" pitchFamily="34" charset="0"/>
              </a:rPr>
              <a:t> Left circumflex artery (</a:t>
            </a:r>
            <a:r>
              <a:rPr lang="en-US" altLang="ko-KR" sz="1800" kern="100" dirty="0" err="1">
                <a:effectLst/>
                <a:latin typeface="맑은 고딕" panose="020B0503020000020004" pitchFamily="50" charset="-127"/>
                <a:ea typeface="맑은 고딕" panose="020B0503020000020004" pitchFamily="50" charset="-127"/>
                <a:cs typeface="Arial" panose="020B0604020202020204" pitchFamily="34" charset="0"/>
              </a:rPr>
              <a:t>LCx</a:t>
            </a:r>
            <a:r>
              <a:rPr lang="en-US" altLang="ko-KR" sz="1800" kern="100" dirty="0">
                <a:effectLst/>
                <a:latin typeface="맑은 고딕" panose="020B0503020000020004" pitchFamily="50" charset="-127"/>
                <a:ea typeface="맑은 고딕" panose="020B0503020000020004" pitchFamily="50" charset="-127"/>
                <a:cs typeface="Arial" panose="020B0604020202020204" pitchFamily="34" charset="0"/>
              </a:rPr>
              <a:t>) and LAD without significant stenosis and occlusion</a:t>
            </a:r>
            <a:endParaRPr lang="ko-KR" altLang="ko-KR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pPr algn="just" latinLnBrk="1">
              <a:lnSpc>
                <a:spcPct val="115000"/>
              </a:lnSpc>
              <a:spcAft>
                <a:spcPts val="800"/>
              </a:spcAft>
            </a:pPr>
            <a:r>
              <a:rPr lang="en-US" altLang="ko-KR" sz="1800" b="1" kern="100" dirty="0">
                <a:effectLst/>
                <a:latin typeface="맑은 고딕" panose="020B0503020000020004" pitchFamily="50" charset="-127"/>
                <a:ea typeface="맑은 고딕" panose="020B0503020000020004" pitchFamily="50" charset="-127"/>
                <a:cs typeface="Arial" panose="020B0604020202020204" pitchFamily="34" charset="0"/>
              </a:rPr>
              <a:t>C.</a:t>
            </a:r>
            <a:r>
              <a:rPr lang="en-US" altLang="ko-KR" sz="1800" kern="100" dirty="0">
                <a:effectLst/>
                <a:latin typeface="맑은 고딕" panose="020B0503020000020004" pitchFamily="50" charset="-127"/>
                <a:ea typeface="맑은 고딕" panose="020B0503020000020004" pitchFamily="50" charset="-127"/>
                <a:cs typeface="Arial" panose="020B0604020202020204" pitchFamily="34" charset="0"/>
              </a:rPr>
              <a:t> Right coronary artery (RCA) without significant stenosis and occlusion</a:t>
            </a:r>
            <a:endParaRPr lang="ko-KR" altLang="ko-KR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35432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65</Words>
  <Application>Microsoft Office PowerPoint</Application>
  <PresentationFormat>Widescreen</PresentationFormat>
  <Paragraphs>1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맑은 고딕</vt:lpstr>
      <vt:lpstr>Arial</vt:lpstr>
      <vt:lpstr>Office 테마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eong-Ho Ok</dc:creator>
  <cp:lastModifiedBy>MDPI</cp:lastModifiedBy>
  <cp:revision>5</cp:revision>
  <dcterms:created xsi:type="dcterms:W3CDTF">2022-05-22T02:57:41Z</dcterms:created>
  <dcterms:modified xsi:type="dcterms:W3CDTF">2022-06-07T10:31:20Z</dcterms:modified>
</cp:coreProperties>
</file>